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nsuk Ko" initials="JK" lastIdx="4" clrIdx="0">
    <p:extLst>
      <p:ext uri="{19B8F6BF-5375-455C-9EA6-DF929625EA0E}">
        <p15:presenceInfo xmlns:p15="http://schemas.microsoft.com/office/powerpoint/2012/main" userId="29f459f36a242a5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523"/>
    <p:restoredTop sz="94675"/>
  </p:normalViewPr>
  <p:slideViewPr>
    <p:cSldViewPr snapToGrid="0" snapToObjects="1">
      <p:cViewPr varScale="1">
        <p:scale>
          <a:sx n="150" d="100"/>
          <a:sy n="150" d="100"/>
        </p:scale>
        <p:origin x="151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747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796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21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840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404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070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363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135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848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043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880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0F91E-FC07-DA4F-8BAC-B0842F797FF5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8411B-A073-3842-A5C3-B3EE18B77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593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2370200-B420-A541-88F5-EC7E03A977E6}"/>
              </a:ext>
            </a:extLst>
          </p:cNvPr>
          <p:cNvSpPr txBox="1"/>
          <p:nvPr/>
        </p:nvSpPr>
        <p:spPr>
          <a:xfrm>
            <a:off x="270933" y="160867"/>
            <a:ext cx="23775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ia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et al,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37EFB05-7B27-FD44-94CE-44916C57424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040" y="930392"/>
            <a:ext cx="310896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1CAE467-FE8F-704C-A6C3-16459CBD979C}"/>
              </a:ext>
            </a:extLst>
          </p:cNvPr>
          <p:cNvSpPr/>
          <p:nvPr/>
        </p:nvSpPr>
        <p:spPr>
          <a:xfrm>
            <a:off x="270933" y="505774"/>
            <a:ext cx="3429000" cy="29097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I, 30-day mortality, unadjusted model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A5E0F27-5814-BA41-87B2-C5DBED62AE8D}"/>
              </a:ext>
            </a:extLst>
          </p:cNvPr>
          <p:cNvSpPr/>
          <p:nvPr/>
        </p:nvSpPr>
        <p:spPr>
          <a:xfrm>
            <a:off x="3564746" y="499761"/>
            <a:ext cx="3429000" cy="29097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STEMI, 30-day mortality, unadjusted model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9972866B-B90E-BC4D-908B-A8B09745212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746" y="930392"/>
            <a:ext cx="3108960" cy="2286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AB506416-758B-134B-AC0C-3642461F9ED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933" y="3453797"/>
            <a:ext cx="310896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0330ECBE-5661-4A46-AA73-D5249D5E67DD}"/>
              </a:ext>
            </a:extLst>
          </p:cNvPr>
          <p:cNvSpPr/>
          <p:nvPr/>
        </p:nvSpPr>
        <p:spPr>
          <a:xfrm>
            <a:off x="160020" y="3176759"/>
            <a:ext cx="3429000" cy="29097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I, 1-year mortality, unadjusted model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EE0D7CE-7AA7-DE42-9B3E-0AA7BB7E5B51}"/>
              </a:ext>
            </a:extLst>
          </p:cNvPr>
          <p:cNvSpPr/>
          <p:nvPr/>
        </p:nvSpPr>
        <p:spPr>
          <a:xfrm>
            <a:off x="3564746" y="3180483"/>
            <a:ext cx="3429000" cy="29097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STEMI, 1-year mortality, unadjusted model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2349490A-F9BD-C54D-AFB0-03B38444EC0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746" y="3502216"/>
            <a:ext cx="310896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6E630296-6819-A147-B2EF-EFEFDCA27180}"/>
              </a:ext>
            </a:extLst>
          </p:cNvPr>
          <p:cNvSpPr/>
          <p:nvPr/>
        </p:nvSpPr>
        <p:spPr>
          <a:xfrm>
            <a:off x="160020" y="6071744"/>
            <a:ext cx="3429000" cy="29097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MI, 1-year recurrence, unadjusted model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ED6AC821-DE3F-4C43-9370-80DD93FD123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933" y="6393477"/>
            <a:ext cx="310896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9664C40D-26EA-5D4B-830F-36CE7861A33C}"/>
              </a:ext>
            </a:extLst>
          </p:cNvPr>
          <p:cNvSpPr/>
          <p:nvPr/>
        </p:nvSpPr>
        <p:spPr>
          <a:xfrm>
            <a:off x="3564746" y="6071744"/>
            <a:ext cx="3429000" cy="29097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STEMI, 1-year recurrence, unadjusted model</a:t>
            </a:r>
            <a:endParaRPr lang="en-US" sz="12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A5DD6882-889C-AE4C-BA67-2CF60DF1347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746" y="6393477"/>
            <a:ext cx="310896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6E6E541-E4DC-164E-A94C-8100152E393E}"/>
              </a:ext>
            </a:extLst>
          </p:cNvPr>
          <p:cNvSpPr txBox="1"/>
          <p:nvPr/>
        </p:nvSpPr>
        <p:spPr>
          <a:xfrm>
            <a:off x="12383" y="52576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35E39EA-7248-8945-8B69-D7602CDADE8E}"/>
              </a:ext>
            </a:extLst>
          </p:cNvPr>
          <p:cNvSpPr txBox="1"/>
          <p:nvPr/>
        </p:nvSpPr>
        <p:spPr>
          <a:xfrm>
            <a:off x="3347682" y="52576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9AC1B4E-3B7C-DF47-8790-F54D988EF883}"/>
              </a:ext>
            </a:extLst>
          </p:cNvPr>
          <p:cNvSpPr txBox="1"/>
          <p:nvPr/>
        </p:nvSpPr>
        <p:spPr>
          <a:xfrm>
            <a:off x="-3703" y="31925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90FAD02-9EC2-D949-B339-22DF24B3D771}"/>
              </a:ext>
            </a:extLst>
          </p:cNvPr>
          <p:cNvSpPr txBox="1"/>
          <p:nvPr/>
        </p:nvSpPr>
        <p:spPr>
          <a:xfrm>
            <a:off x="3331596" y="31925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F579C56-4950-6148-8379-FB40DAA23D1E}"/>
              </a:ext>
            </a:extLst>
          </p:cNvPr>
          <p:cNvSpPr txBox="1"/>
          <p:nvPr/>
        </p:nvSpPr>
        <p:spPr>
          <a:xfrm>
            <a:off x="12383" y="60857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718C05B-DE5A-AB4B-8727-47C5DBCAAAA9}"/>
              </a:ext>
            </a:extLst>
          </p:cNvPr>
          <p:cNvSpPr txBox="1"/>
          <p:nvPr/>
        </p:nvSpPr>
        <p:spPr>
          <a:xfrm>
            <a:off x="3347682" y="608572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270595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55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suk Ko</dc:creator>
  <cp:lastModifiedBy>Junsuk Ko</cp:lastModifiedBy>
  <cp:revision>36</cp:revision>
  <dcterms:created xsi:type="dcterms:W3CDTF">2021-02-22T13:01:03Z</dcterms:created>
  <dcterms:modified xsi:type="dcterms:W3CDTF">2021-02-23T10:48:21Z</dcterms:modified>
</cp:coreProperties>
</file>